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364" r:id="rId2"/>
  </p:sldIdLst>
  <p:sldSz cx="18000663" cy="14400213"/>
  <p:notesSz cx="9926638" cy="6797675"/>
  <p:defaultTextStyle>
    <a:defPPr>
      <a:defRPr lang="ko-KR"/>
    </a:defPPr>
    <a:lvl1pPr marL="0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1pPr>
    <a:lvl2pPr marL="925739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2pPr>
    <a:lvl3pPr marL="1851477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3pPr>
    <a:lvl4pPr marL="2777216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4pPr>
    <a:lvl5pPr marL="3702954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5pPr>
    <a:lvl6pPr marL="4628693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6pPr>
    <a:lvl7pPr marL="5554431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7pPr>
    <a:lvl8pPr marL="6480170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8pPr>
    <a:lvl9pPr marL="7405908" algn="l" defTabSz="1851477" rtl="0" eaLnBrk="1" latinLnBrk="1" hangingPunct="1">
      <a:defRPr sz="364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81" userDrawn="1">
          <p15:clr>
            <a:srgbClr val="A4A3A4"/>
          </p15:clr>
        </p15:guide>
        <p15:guide id="2" pos="55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70B5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19" autoAdjust="0"/>
    <p:restoredTop sz="93343" autoAdjust="0"/>
  </p:normalViewPr>
  <p:slideViewPr>
    <p:cSldViewPr snapToGrid="0" showGuides="1">
      <p:cViewPr varScale="1">
        <p:scale>
          <a:sx n="28" d="100"/>
          <a:sy n="28" d="100"/>
        </p:scale>
        <p:origin x="1260" y="32"/>
      </p:cViewPr>
      <p:guideLst>
        <p:guide orient="horz" pos="4581"/>
        <p:guide pos="55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0E09C-C9D3-4408-B620-F75D631D088D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5A743C-867F-4480-AECF-618A25AA57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31618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B5825F-D85D-4232-A0B4-E6911F1B9680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530600" y="850900"/>
            <a:ext cx="2865438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2665" y="3271381"/>
            <a:ext cx="794131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08B7D4-F36D-4BC6-B6E1-5F8F71F39BA5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33300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1pPr>
    <a:lvl2pPr marL="925739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2pPr>
    <a:lvl3pPr marL="1851477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3pPr>
    <a:lvl4pPr marL="2777216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4pPr>
    <a:lvl5pPr marL="3702954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5pPr>
    <a:lvl6pPr marL="4628693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6pPr>
    <a:lvl7pPr marL="5554431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7pPr>
    <a:lvl8pPr marL="6480170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8pPr>
    <a:lvl9pPr marL="7405908" algn="l" defTabSz="1851477" rtl="0" eaLnBrk="1" latinLnBrk="1" hangingPunct="1">
      <a:defRPr sz="243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356703"/>
            <a:ext cx="15300564" cy="50134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563446"/>
            <a:ext cx="13500497" cy="347671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8695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0740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66678"/>
            <a:ext cx="3881393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66678"/>
            <a:ext cx="11419171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7307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477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90057"/>
            <a:ext cx="15525572" cy="59900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636813"/>
            <a:ext cx="15525572" cy="315004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0235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833390"/>
            <a:ext cx="7650282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833390"/>
            <a:ext cx="7650282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5213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66681"/>
            <a:ext cx="15525572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530053"/>
            <a:ext cx="7615123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260078"/>
            <a:ext cx="7615123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530053"/>
            <a:ext cx="7652626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260078"/>
            <a:ext cx="7652626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588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9218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110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73367"/>
            <a:ext cx="9112836" cy="10233485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3268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73367"/>
            <a:ext cx="9112836" cy="10233485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5939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66681"/>
            <a:ext cx="1552557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833390"/>
            <a:ext cx="1552557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D3C82-92DB-488E-BFF2-34F7E7FBE996}" type="datetimeFigureOut">
              <a:rPr lang="ko-KR" altLang="en-US" smtClean="0"/>
              <a:pPr/>
              <a:t>2018-0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346867"/>
            <a:ext cx="607522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9B654B-8CDA-4BCB-8E56-5E46D9F6B2C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064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1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1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1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eg"/><Relationship Id="rId7" Type="http://schemas.openxmlformats.org/officeDocument/2006/relationships/image" Target="../media/image6.jp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11" Type="http://schemas.openxmlformats.org/officeDocument/2006/relationships/image" Target="../media/image10.jpe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4" Type="http://schemas.openxmlformats.org/officeDocument/2006/relationships/image" Target="../media/image3.jpe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TextBox 192"/>
          <p:cNvSpPr txBox="1"/>
          <p:nvPr/>
        </p:nvSpPr>
        <p:spPr>
          <a:xfrm>
            <a:off x="9733817" y="4020073"/>
            <a:ext cx="4587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200" dirty="0" smtClean="0">
                <a:latin typeface="Arial"/>
                <a:ea typeface="Arial" charset="0"/>
                <a:cs typeface="Arial"/>
              </a:rPr>
              <a:t>B</a:t>
            </a:r>
            <a:endParaRPr lang="ko-KR" altLang="en-US" sz="32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9910485" y="7885508"/>
            <a:ext cx="9807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200" dirty="0" smtClean="0">
                <a:latin typeface="Arial"/>
                <a:ea typeface="Arial" charset="0"/>
                <a:cs typeface="Arial"/>
              </a:rPr>
              <a:t>C</a:t>
            </a:r>
            <a:endParaRPr lang="ko-KR" altLang="en-US" sz="3200" dirty="0">
              <a:latin typeface="Arial"/>
              <a:ea typeface="Arial" charset="0"/>
              <a:cs typeface="Arial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395121" y="4020073"/>
            <a:ext cx="4587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200" dirty="0" smtClean="0">
                <a:latin typeface="Arial"/>
                <a:ea typeface="Arial" charset="0"/>
                <a:cs typeface="Arial"/>
              </a:rPr>
              <a:t>A</a:t>
            </a:r>
            <a:endParaRPr lang="ko-KR" altLang="en-US" sz="3200" dirty="0">
              <a:latin typeface="Arial"/>
              <a:ea typeface="Arial" charset="0"/>
              <a:cs typeface="Arial"/>
            </a:endParaRPr>
          </a:p>
        </p:txBody>
      </p:sp>
      <p:grpSp>
        <p:nvGrpSpPr>
          <p:cNvPr id="18" name="그룹 17"/>
          <p:cNvGrpSpPr/>
          <p:nvPr/>
        </p:nvGrpSpPr>
        <p:grpSpPr>
          <a:xfrm>
            <a:off x="9770012" y="7386071"/>
            <a:ext cx="5955110" cy="3465407"/>
            <a:chOff x="1607303" y="7360268"/>
            <a:chExt cx="5955110" cy="3465407"/>
          </a:xfrm>
        </p:grpSpPr>
        <p:pic>
          <p:nvPicPr>
            <p:cNvPr id="90" name="그림 89"/>
            <p:cNvPicPr preferRelativeResize="0"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6774" y="10231675"/>
              <a:ext cx="4320000" cy="594000"/>
            </a:xfrm>
            <a:prstGeom prst="rect">
              <a:avLst/>
            </a:prstGeom>
          </p:spPr>
        </p:pic>
        <p:pic>
          <p:nvPicPr>
            <p:cNvPr id="91" name="그림 90"/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6774" y="8929623"/>
              <a:ext cx="4320000" cy="594000"/>
            </a:xfrm>
            <a:prstGeom prst="rect">
              <a:avLst/>
            </a:prstGeom>
          </p:spPr>
        </p:pic>
        <p:pic>
          <p:nvPicPr>
            <p:cNvPr id="92" name="그림 91"/>
            <p:cNvPicPr preferRelativeResize="0"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6774" y="9582805"/>
              <a:ext cx="4320000" cy="594000"/>
            </a:xfrm>
            <a:prstGeom prst="rect">
              <a:avLst/>
            </a:prstGeom>
          </p:spPr>
        </p:pic>
        <p:cxnSp>
          <p:nvCxnSpPr>
            <p:cNvPr id="94" name="직선 연결선 93"/>
            <p:cNvCxnSpPr/>
            <p:nvPr/>
          </p:nvCxnSpPr>
          <p:spPr>
            <a:xfrm flipV="1">
              <a:off x="6600104" y="10363169"/>
              <a:ext cx="181088" cy="11499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0" name="그룹 109"/>
            <p:cNvGrpSpPr/>
            <p:nvPr/>
          </p:nvGrpSpPr>
          <p:grpSpPr>
            <a:xfrm>
              <a:off x="2837269" y="7360268"/>
              <a:ext cx="4725144" cy="1789821"/>
              <a:chOff x="922216" y="621076"/>
              <a:chExt cx="2689896" cy="1107123"/>
            </a:xfrm>
          </p:grpSpPr>
          <p:sp>
            <p:nvSpPr>
              <p:cNvPr id="111" name="직사각형 110"/>
              <p:cNvSpPr/>
              <p:nvPr/>
            </p:nvSpPr>
            <p:spPr>
              <a:xfrm rot="19095872">
                <a:off x="2736725" y="943183"/>
                <a:ext cx="875387" cy="43787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ko-KR" sz="2000" dirty="0">
                    <a:solidFill>
                      <a:srgbClr val="000000"/>
                    </a:solidFill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2000" dirty="0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CD3/</a:t>
                </a:r>
              </a:p>
              <a:p>
                <a:pPr algn="ctr"/>
                <a:r>
                  <a:rPr lang="en-US" altLang="ko-KR" sz="2000" dirty="0">
                    <a:solidFill>
                      <a:srgbClr val="000000"/>
                    </a:solidFill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2000" dirty="0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CD28 Abs</a:t>
                </a: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 rot="19095872">
                <a:off x="1434273" y="1171194"/>
                <a:ext cx="510296" cy="2474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PMA/I</a:t>
                </a:r>
                <a:endParaRPr lang="ko-KR" altLang="en-US" sz="2000" dirty="0">
                  <a:latin typeface="Arial" panose="020B0604020202020204" pitchFamily="34" charset="0"/>
                  <a:ea typeface="함초롬바탕" panose="02030604000101010101" pitchFamily="18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 rot="19095872">
                <a:off x="1921655" y="1183282"/>
                <a:ext cx="389840" cy="2474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LPS</a:t>
                </a:r>
                <a:endParaRPr lang="ko-KR" altLang="en-US" sz="2000" dirty="0">
                  <a:latin typeface="Arial" panose="020B0604020202020204" pitchFamily="34" charset="0"/>
                  <a:ea typeface="함초롬바탕" panose="02030604000101010101" pitchFamily="18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 rot="19095872">
                <a:off x="2288582" y="1143800"/>
                <a:ext cx="471057" cy="2474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err="1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ConA</a:t>
                </a:r>
                <a:endParaRPr lang="ko-KR" altLang="en-US" sz="2000" dirty="0">
                  <a:latin typeface="Arial" panose="020B0604020202020204" pitchFamily="34" charset="0"/>
                  <a:ea typeface="함초롬바탕" panose="02030604000101010101" pitchFamily="18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 rot="16200000">
                <a:off x="482540" y="1060752"/>
                <a:ext cx="1107123" cy="2277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2000" b="1" dirty="0" smtClean="0">
                    <a:latin typeface="Arial" panose="020B0604020202020204" pitchFamily="34" charset="0"/>
                    <a:ea typeface="함초롬바탕" panose="02030504000101010101" pitchFamily="18" charset="-127"/>
                    <a:cs typeface="Arial" panose="020B0604020202020204" pitchFamily="34" charset="0"/>
                  </a:rPr>
                  <a:t>UC-MSC</a:t>
                </a:r>
                <a:endParaRPr lang="en-US" altLang="ko-KR" sz="2000" b="1" dirty="0">
                  <a:latin typeface="Arial" panose="020B0604020202020204" pitchFamily="34" charset="0"/>
                  <a:ea typeface="함초롬바탕" panose="02030504000101010101" pitchFamily="18" charset="-127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그룹 12"/>
            <p:cNvGrpSpPr/>
            <p:nvPr/>
          </p:nvGrpSpPr>
          <p:grpSpPr>
            <a:xfrm>
              <a:off x="1607303" y="9086482"/>
              <a:ext cx="1014305" cy="1572867"/>
              <a:chOff x="1607303" y="9086482"/>
              <a:chExt cx="1014305" cy="1572867"/>
            </a:xfrm>
          </p:grpSpPr>
          <p:sp>
            <p:nvSpPr>
              <p:cNvPr id="118" name="TextBox 117"/>
              <p:cNvSpPr txBox="1"/>
              <p:nvPr/>
            </p:nvSpPr>
            <p:spPr>
              <a:xfrm>
                <a:off x="1653073" y="9086482"/>
                <a:ext cx="96853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X-2</a:t>
                </a:r>
                <a:endParaRPr lang="ko-KR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1966375" y="9687083"/>
                <a:ext cx="63991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DO</a:t>
                </a:r>
                <a:endParaRPr lang="ko-KR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1607303" y="10259239"/>
                <a:ext cx="99899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RPS18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5" name="그룹 14"/>
          <p:cNvGrpSpPr/>
          <p:nvPr/>
        </p:nvGrpSpPr>
        <p:grpSpPr>
          <a:xfrm>
            <a:off x="9674817" y="4293373"/>
            <a:ext cx="5486308" cy="2934307"/>
            <a:chOff x="10092221" y="7891368"/>
            <a:chExt cx="5486308" cy="2934307"/>
          </a:xfrm>
        </p:grpSpPr>
        <p:pic>
          <p:nvPicPr>
            <p:cNvPr id="206" name="그림 205"/>
            <p:cNvPicPr preferRelativeResize="0"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58529" y="9582805"/>
              <a:ext cx="4320000" cy="594000"/>
            </a:xfrm>
            <a:prstGeom prst="rect">
              <a:avLst/>
            </a:prstGeom>
          </p:spPr>
        </p:pic>
        <p:pic>
          <p:nvPicPr>
            <p:cNvPr id="207" name="그림 206"/>
            <p:cNvPicPr preferRelativeResize="0"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58529" y="10231675"/>
              <a:ext cx="4320000" cy="594000"/>
            </a:xfrm>
            <a:prstGeom prst="rect">
              <a:avLst/>
            </a:prstGeom>
          </p:spPr>
        </p:pic>
        <p:grpSp>
          <p:nvGrpSpPr>
            <p:cNvPr id="14" name="그룹 13"/>
            <p:cNvGrpSpPr/>
            <p:nvPr/>
          </p:nvGrpSpPr>
          <p:grpSpPr>
            <a:xfrm>
              <a:off x="10256508" y="7891368"/>
              <a:ext cx="5178345" cy="979321"/>
              <a:chOff x="10256508" y="7561039"/>
              <a:chExt cx="5178345" cy="979321"/>
            </a:xfrm>
          </p:grpSpPr>
          <p:sp>
            <p:nvSpPr>
              <p:cNvPr id="211" name="TextBox 210"/>
              <p:cNvSpPr txBox="1"/>
              <p:nvPr/>
            </p:nvSpPr>
            <p:spPr>
              <a:xfrm>
                <a:off x="10256508" y="8109177"/>
                <a:ext cx="81144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l-GR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>
                <a:off x="11585722" y="8140250"/>
                <a:ext cx="384913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       +       -         +        -         + 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3" name="직선 연결선 212"/>
              <p:cNvCxnSpPr/>
              <p:nvPr/>
            </p:nvCxnSpPr>
            <p:spPr>
              <a:xfrm>
                <a:off x="11538213" y="8025950"/>
                <a:ext cx="10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직선 연결선 213"/>
              <p:cNvCxnSpPr/>
              <p:nvPr/>
            </p:nvCxnSpPr>
            <p:spPr>
              <a:xfrm>
                <a:off x="12900288" y="8025950"/>
                <a:ext cx="10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직선 연결선 214"/>
              <p:cNvCxnSpPr/>
              <p:nvPr/>
            </p:nvCxnSpPr>
            <p:spPr>
              <a:xfrm>
                <a:off x="14262363" y="8025950"/>
                <a:ext cx="10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6" name="직사각형 215"/>
              <p:cNvSpPr/>
              <p:nvPr/>
            </p:nvSpPr>
            <p:spPr>
              <a:xfrm>
                <a:off x="11472117" y="7561039"/>
                <a:ext cx="1212191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latinLnBrk="0"/>
                <a:r>
                  <a:rPr lang="en-US" altLang="ko-KR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UC-MSC</a:t>
                </a:r>
                <a:endParaRPr lang="ko-KR" altLang="ko-KR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직사각형 216"/>
              <p:cNvSpPr/>
              <p:nvPr/>
            </p:nvSpPr>
            <p:spPr>
              <a:xfrm>
                <a:off x="12901666" y="7561039"/>
                <a:ext cx="1197765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latinLnBrk="0"/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D-MSC</a:t>
                </a:r>
                <a:endParaRPr lang="ko-KR" altLang="ko-KR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직사각형 217"/>
              <p:cNvSpPr/>
              <p:nvPr/>
            </p:nvSpPr>
            <p:spPr>
              <a:xfrm>
                <a:off x="14316789" y="7561039"/>
                <a:ext cx="1042273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latinLnBrk="0"/>
                <a:r>
                  <a:rPr lang="en-US" altLang="ko-KR" sz="2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DLSC</a:t>
                </a:r>
                <a:endParaRPr lang="ko-KR" altLang="ko-KR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19" name="그림 218"/>
            <p:cNvPicPr preferRelativeResize="0"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58529" y="8929623"/>
              <a:ext cx="4320000" cy="594000"/>
            </a:xfrm>
            <a:prstGeom prst="rect">
              <a:avLst/>
            </a:prstGeom>
          </p:spPr>
        </p:pic>
        <p:grpSp>
          <p:nvGrpSpPr>
            <p:cNvPr id="126" name="그룹 125"/>
            <p:cNvGrpSpPr/>
            <p:nvPr/>
          </p:nvGrpSpPr>
          <p:grpSpPr>
            <a:xfrm>
              <a:off x="10092221" y="9086482"/>
              <a:ext cx="1014305" cy="1572867"/>
              <a:chOff x="1607303" y="9086482"/>
              <a:chExt cx="1014305" cy="1572867"/>
            </a:xfrm>
          </p:grpSpPr>
          <p:sp>
            <p:nvSpPr>
              <p:cNvPr id="127" name="TextBox 126"/>
              <p:cNvSpPr txBox="1"/>
              <p:nvPr/>
            </p:nvSpPr>
            <p:spPr>
              <a:xfrm>
                <a:off x="1653073" y="9086482"/>
                <a:ext cx="96853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X-2</a:t>
                </a:r>
                <a:endParaRPr lang="ko-KR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1966375" y="9687083"/>
                <a:ext cx="63991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DO</a:t>
                </a:r>
                <a:endParaRPr lang="ko-KR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1607303" y="10259239"/>
                <a:ext cx="99899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RPS18</a:t>
                </a:r>
                <a:endParaRPr lang="ko-KR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00" name="직사각형 99"/>
          <p:cNvSpPr/>
          <p:nvPr/>
        </p:nvSpPr>
        <p:spPr>
          <a:xfrm>
            <a:off x="1007603" y="1869290"/>
            <a:ext cx="8308361" cy="7483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4725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US" altLang="ko-KR" sz="472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4725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4725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3225332" y="3651154"/>
            <a:ext cx="6090632" cy="7867395"/>
            <a:chOff x="3225332" y="3651154"/>
            <a:chExt cx="6090632" cy="7867395"/>
          </a:xfrm>
        </p:grpSpPr>
        <p:sp>
          <p:nvSpPr>
            <p:cNvPr id="38" name="직사각형 37"/>
            <p:cNvSpPr/>
            <p:nvPr/>
          </p:nvSpPr>
          <p:spPr>
            <a:xfrm>
              <a:off x="4303218" y="11149217"/>
              <a:ext cx="5012746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800" dirty="0">
                  <a:latin typeface="Comic Sans MS" panose="030F0702030302020204" pitchFamily="66" charset="0"/>
                  <a:ea typeface="함초롬바탕" panose="02030504000101010101" pitchFamily="18" charset="-127"/>
                  <a:cs typeface="함초롬바탕" panose="02030504000101010101" pitchFamily="18" charset="-127"/>
                </a:rPr>
                <a:t>* RPS18; ribosomal protein S18 (RPS18) </a:t>
              </a:r>
              <a:endParaRPr lang="ko-KR" altLang="en-US" sz="1800" dirty="0">
                <a:latin typeface="Comic Sans MS" panose="030F0702030302020204" pitchFamily="66" charset="0"/>
                <a:ea typeface="함초롬바탕" panose="02030504000101010101" pitchFamily="18" charset="-127"/>
                <a:cs typeface="함초롬바탕" panose="02030504000101010101" pitchFamily="18" charset="-127"/>
              </a:endParaRPr>
            </a:p>
          </p:txBody>
        </p:sp>
        <p:grpSp>
          <p:nvGrpSpPr>
            <p:cNvPr id="58" name="그룹 57"/>
            <p:cNvGrpSpPr/>
            <p:nvPr/>
          </p:nvGrpSpPr>
          <p:grpSpPr>
            <a:xfrm>
              <a:off x="4303262" y="5182776"/>
              <a:ext cx="4404101" cy="1902672"/>
              <a:chOff x="1833348" y="10702891"/>
              <a:chExt cx="7086875" cy="3264122"/>
            </a:xfrm>
          </p:grpSpPr>
          <p:pic>
            <p:nvPicPr>
              <p:cNvPr id="22" name="그림 21"/>
              <p:cNvPicPr preferRelativeResize="0">
                <a:picLocks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33348" y="12903982"/>
                <a:ext cx="7086875" cy="1063031"/>
              </a:xfrm>
              <a:prstGeom prst="rect">
                <a:avLst/>
              </a:prstGeom>
            </p:spPr>
          </p:pic>
          <p:pic>
            <p:nvPicPr>
              <p:cNvPr id="23" name="그림 22"/>
              <p:cNvPicPr preferRelativeResize="0">
                <a:picLocks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33348" y="10702891"/>
                <a:ext cx="7086875" cy="1063031"/>
              </a:xfrm>
              <a:prstGeom prst="rect">
                <a:avLst/>
              </a:prstGeom>
            </p:spPr>
          </p:pic>
          <p:pic>
            <p:nvPicPr>
              <p:cNvPr id="24" name="그림 23"/>
              <p:cNvPicPr preferRelativeResize="0">
                <a:picLocks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33348" y="11803435"/>
                <a:ext cx="7086875" cy="1063031"/>
              </a:xfrm>
              <a:prstGeom prst="rect">
                <a:avLst/>
              </a:prstGeom>
            </p:spPr>
          </p:pic>
        </p:grpSp>
        <p:grpSp>
          <p:nvGrpSpPr>
            <p:cNvPr id="59" name="그룹 58"/>
            <p:cNvGrpSpPr/>
            <p:nvPr/>
          </p:nvGrpSpPr>
          <p:grpSpPr>
            <a:xfrm>
              <a:off x="5313693" y="3651154"/>
              <a:ext cx="3881303" cy="1439959"/>
              <a:chOff x="1402592" y="699200"/>
              <a:chExt cx="2209520" cy="890707"/>
            </a:xfrm>
          </p:grpSpPr>
          <p:sp>
            <p:nvSpPr>
              <p:cNvPr id="60" name="직사각형 59"/>
              <p:cNvSpPr/>
              <p:nvPr/>
            </p:nvSpPr>
            <p:spPr>
              <a:xfrm rot="19095872">
                <a:off x="2736725" y="699200"/>
                <a:ext cx="875387" cy="43787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ko-KR" sz="2000" dirty="0">
                    <a:solidFill>
                      <a:srgbClr val="000000"/>
                    </a:solidFill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2000" dirty="0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CD3/</a:t>
                </a:r>
              </a:p>
              <a:p>
                <a:pPr algn="ctr"/>
                <a:r>
                  <a:rPr lang="en-US" altLang="ko-KR" sz="2000" dirty="0">
                    <a:solidFill>
                      <a:srgbClr val="000000"/>
                    </a:solidFill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α</a:t>
                </a:r>
                <a:r>
                  <a:rPr lang="en-US" altLang="ko-KR" sz="2000" dirty="0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CD28 Abs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rot="19095872">
                <a:off x="1434273" y="927211"/>
                <a:ext cx="510296" cy="2474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PMA/I</a:t>
                </a:r>
                <a:endParaRPr lang="ko-KR" altLang="en-US" sz="2000" dirty="0">
                  <a:latin typeface="Arial" panose="020B0604020202020204" pitchFamily="34" charset="0"/>
                  <a:ea typeface="함초롬바탕" panose="02030604000101010101" pitchFamily="18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rot="19095872">
                <a:off x="1921655" y="939300"/>
                <a:ext cx="389840" cy="2474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LPS</a:t>
                </a:r>
                <a:endParaRPr lang="ko-KR" altLang="en-US" sz="2000" dirty="0">
                  <a:latin typeface="Arial" panose="020B0604020202020204" pitchFamily="34" charset="0"/>
                  <a:ea typeface="함초롬바탕" panose="02030604000101010101" pitchFamily="18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rot="19095872">
                <a:off x="2288582" y="899817"/>
                <a:ext cx="471057" cy="2474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 err="1">
                    <a:latin typeface="Arial" panose="020B0604020202020204" pitchFamily="34" charset="0"/>
                    <a:ea typeface="함초롬바탕" panose="02030604000101010101" pitchFamily="18" charset="-127"/>
                    <a:cs typeface="Arial" panose="020B0604020202020204" pitchFamily="34" charset="0"/>
                  </a:rPr>
                  <a:t>ConA</a:t>
                </a:r>
                <a:endParaRPr lang="ko-KR" altLang="en-US" sz="2000" dirty="0">
                  <a:latin typeface="Arial" panose="020B0604020202020204" pitchFamily="34" charset="0"/>
                  <a:ea typeface="함초롬바탕" panose="02030604000101010101" pitchFamily="18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65" name="직선 연결선 64"/>
              <p:cNvCxnSpPr/>
              <p:nvPr/>
            </p:nvCxnSpPr>
            <p:spPr>
              <a:xfrm>
                <a:off x="1402592" y="1299670"/>
                <a:ext cx="180345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xtBox 65"/>
              <p:cNvSpPr txBox="1"/>
              <p:nvPr/>
            </p:nvSpPr>
            <p:spPr>
              <a:xfrm>
                <a:off x="1582157" y="1342412"/>
                <a:ext cx="1429230" cy="2474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2000" dirty="0">
                    <a:latin typeface="Arial" panose="020B0604020202020204" pitchFamily="34" charset="0"/>
                    <a:ea typeface="함초롬바탕" panose="02030504000101010101" pitchFamily="18" charset="-127"/>
                    <a:cs typeface="Arial" panose="020B0604020202020204" pitchFamily="34" charset="0"/>
                  </a:rPr>
                  <a:t>MSC + CM for 1 day</a:t>
                </a: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3255788" y="5269835"/>
              <a:ext cx="96853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OX-2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584404" y="5909595"/>
              <a:ext cx="63991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IDO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225332" y="6510196"/>
              <a:ext cx="99899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RPS18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 rot="16200000">
              <a:off x="8101375" y="5962143"/>
              <a:ext cx="1789821" cy="400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 smtClean="0">
                  <a:latin typeface="Arial" panose="020B0604020202020204" pitchFamily="34" charset="0"/>
                  <a:ea typeface="함초롬바탕" panose="02030504000101010101" pitchFamily="18" charset="-127"/>
                  <a:cs typeface="Arial" panose="020B0604020202020204" pitchFamily="34" charset="0"/>
                </a:rPr>
                <a:t>PDLSC</a:t>
              </a:r>
              <a:endParaRPr lang="en-US" altLang="ko-KR" sz="2000" b="1" dirty="0">
                <a:latin typeface="Arial" panose="020B0604020202020204" pitchFamily="34" charset="0"/>
                <a:ea typeface="함초롬바탕" panose="02030504000101010101" pitchFamily="18" charset="-127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993751" y="4762533"/>
              <a:ext cx="1789820" cy="4001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dirty="0" smtClean="0">
                  <a:latin typeface="Arial" panose="020B0604020202020204" pitchFamily="34" charset="0"/>
                  <a:ea typeface="함초롬바탕" panose="02030504000101010101" pitchFamily="18" charset="-127"/>
                  <a:cs typeface="Arial" panose="020B0604020202020204" pitchFamily="34" charset="0"/>
                </a:rPr>
                <a:t>naive</a:t>
              </a:r>
              <a:endParaRPr lang="en-US" altLang="ko-KR" sz="2000" dirty="0">
                <a:latin typeface="Arial" panose="020B0604020202020204" pitchFamily="34" charset="0"/>
                <a:ea typeface="함초롬바탕" panose="02030504000101010101" pitchFamily="18" charset="-127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8101375" y="7927718"/>
              <a:ext cx="178982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 smtClean="0">
                  <a:latin typeface="Arial" panose="020B0604020202020204" pitchFamily="34" charset="0"/>
                  <a:ea typeface="함초롬바탕" panose="02030504000101010101" pitchFamily="18" charset="-127"/>
                  <a:cs typeface="Arial" panose="020B0604020202020204" pitchFamily="34" charset="0"/>
                </a:rPr>
                <a:t>UC-MSC</a:t>
              </a:r>
              <a:endParaRPr lang="en-US" altLang="ko-KR" sz="2000" b="1" dirty="0">
                <a:latin typeface="Arial" panose="020B0604020202020204" pitchFamily="34" charset="0"/>
                <a:ea typeface="함초롬바탕" panose="02030504000101010101" pitchFamily="18" charset="-127"/>
                <a:cs typeface="Arial" panose="020B0604020202020204" pitchFamily="34" charset="0"/>
              </a:endParaRPr>
            </a:p>
          </p:txBody>
        </p:sp>
        <p:grpSp>
          <p:nvGrpSpPr>
            <p:cNvPr id="26" name="그룹 25"/>
            <p:cNvGrpSpPr/>
            <p:nvPr/>
          </p:nvGrpSpPr>
          <p:grpSpPr>
            <a:xfrm>
              <a:off x="4303262" y="7166886"/>
              <a:ext cx="4366800" cy="1870624"/>
              <a:chOff x="2656627" y="4092907"/>
              <a:chExt cx="4366800" cy="1870624"/>
            </a:xfrm>
          </p:grpSpPr>
          <p:pic>
            <p:nvPicPr>
              <p:cNvPr id="7" name="그림 6"/>
              <p:cNvPicPr preferRelativeResize="0">
                <a:picLocks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57254" y="4092907"/>
                <a:ext cx="4366173" cy="594070"/>
              </a:xfrm>
              <a:prstGeom prst="rect">
                <a:avLst/>
              </a:prstGeom>
            </p:spPr>
          </p:pic>
          <p:pic>
            <p:nvPicPr>
              <p:cNvPr id="11" name="그림 10"/>
              <p:cNvPicPr preferRelativeResize="0">
                <a:picLocks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57254" y="5369461"/>
                <a:ext cx="4366173" cy="594070"/>
              </a:xfrm>
              <a:prstGeom prst="rect">
                <a:avLst/>
              </a:prstGeom>
            </p:spPr>
          </p:pic>
          <p:pic>
            <p:nvPicPr>
              <p:cNvPr id="16" name="그림 15"/>
              <p:cNvPicPr preferRelativeResize="0">
                <a:picLocks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56627" y="4726074"/>
                <a:ext cx="4366800" cy="594000"/>
              </a:xfrm>
              <a:prstGeom prst="rect">
                <a:avLst/>
              </a:prstGeom>
            </p:spPr>
          </p:pic>
        </p:grpSp>
        <p:sp>
          <p:nvSpPr>
            <p:cNvPr id="104" name="TextBox 103"/>
            <p:cNvSpPr txBox="1"/>
            <p:nvPr/>
          </p:nvSpPr>
          <p:spPr>
            <a:xfrm>
              <a:off x="3255788" y="7267079"/>
              <a:ext cx="96853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OX-2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584404" y="7906839"/>
              <a:ext cx="63991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IDO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225332" y="8507440"/>
              <a:ext cx="99899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RPS18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7" name="그룹 56"/>
            <p:cNvGrpSpPr/>
            <p:nvPr/>
          </p:nvGrpSpPr>
          <p:grpSpPr>
            <a:xfrm>
              <a:off x="4303262" y="9132193"/>
              <a:ext cx="4400063" cy="1908139"/>
              <a:chOff x="1812669" y="7161587"/>
              <a:chExt cx="7086875" cy="3327152"/>
            </a:xfrm>
          </p:grpSpPr>
          <p:pic>
            <p:nvPicPr>
              <p:cNvPr id="19" name="그림 18"/>
              <p:cNvPicPr preferRelativeResize="0">
                <a:picLocks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12669" y="9425708"/>
                <a:ext cx="7086875" cy="1063031"/>
              </a:xfrm>
              <a:prstGeom prst="rect">
                <a:avLst/>
              </a:prstGeom>
            </p:spPr>
          </p:pic>
          <p:pic>
            <p:nvPicPr>
              <p:cNvPr id="20" name="그림 19"/>
              <p:cNvPicPr preferRelativeResize="0">
                <a:picLocks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12669" y="7161587"/>
                <a:ext cx="7086875" cy="1063031"/>
              </a:xfrm>
              <a:prstGeom prst="rect">
                <a:avLst/>
              </a:prstGeom>
            </p:spPr>
          </p:pic>
          <p:pic>
            <p:nvPicPr>
              <p:cNvPr id="21" name="그림 20"/>
              <p:cNvPicPr preferRelativeResize="0">
                <a:picLocks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12669" y="8293648"/>
                <a:ext cx="7086875" cy="1063031"/>
              </a:xfrm>
              <a:prstGeom prst="rect">
                <a:avLst/>
              </a:prstGeom>
            </p:spPr>
          </p:pic>
        </p:grpSp>
        <p:sp>
          <p:nvSpPr>
            <p:cNvPr id="72" name="TextBox 71"/>
            <p:cNvSpPr txBox="1"/>
            <p:nvPr/>
          </p:nvSpPr>
          <p:spPr>
            <a:xfrm rot="16200000">
              <a:off x="8101375" y="9893291"/>
              <a:ext cx="178982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 smtClean="0">
                  <a:latin typeface="Arial" panose="020B0604020202020204" pitchFamily="34" charset="0"/>
                  <a:ea typeface="함초롬바탕" panose="02030504000101010101" pitchFamily="18" charset="-127"/>
                  <a:cs typeface="Arial" panose="020B0604020202020204" pitchFamily="34" charset="0"/>
                </a:rPr>
                <a:t>AD-MSC</a:t>
              </a:r>
              <a:endParaRPr lang="en-US" altLang="ko-KR" sz="2000" b="1" dirty="0">
                <a:latin typeface="Arial" panose="020B0604020202020204" pitchFamily="34" charset="0"/>
                <a:ea typeface="함초롬바탕" panose="02030504000101010101" pitchFamily="18" charset="-127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3255788" y="9200151"/>
              <a:ext cx="96853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OX-2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3584404" y="9839911"/>
              <a:ext cx="63991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IDO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225332" y="10440512"/>
              <a:ext cx="99899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RPS18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029675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692</TotalTime>
  <Words>67</Words>
  <Application>Microsoft Office PowerPoint</Application>
  <PresentationFormat>사용자 지정</PresentationFormat>
  <Paragraphs>4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함초롬바탕</vt:lpstr>
      <vt:lpstr>Arial</vt:lpstr>
      <vt:lpstr>Calibri</vt:lpstr>
      <vt:lpstr>Calibri Light</vt:lpstr>
      <vt:lpstr>Comic Sans MS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진희</dc:creator>
  <cp:lastModifiedBy>황영일</cp:lastModifiedBy>
  <cp:revision>558</cp:revision>
  <cp:lastPrinted>2017-06-10T01:06:02Z</cp:lastPrinted>
  <dcterms:created xsi:type="dcterms:W3CDTF">2016-08-07T03:25:07Z</dcterms:created>
  <dcterms:modified xsi:type="dcterms:W3CDTF">2018-01-02T08:43:48Z</dcterms:modified>
</cp:coreProperties>
</file>